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6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68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297071-6A80-F500-8480-2EDA2DB6E5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985BD5-7726-A803-054C-C51B08F9E2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9D0DC4-2ABE-E023-AC77-C4AB8ACF6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B767DB-D61D-F475-23DD-0A0E7CDAB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ACDD6D-ABDF-772C-E43D-5F4E743EA9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077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EBBEC5-BC36-FC45-E0EF-707CC91BDC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452FC2-A2B9-FB20-E21F-521F296BD0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B120F3-C6FF-71DB-68CE-FA92BB4E2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7556C-319F-AD4A-179A-9AF5E79C7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6E7792-C357-4D94-30FA-ED11020DF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851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8BD50B-2D9D-E21E-444F-EB8B4A6770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CCF236-8BA0-C763-1889-F8AC52A736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F959F1-0534-52AB-B8DA-9C0D04355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C92998-B3A2-877F-C240-97CE965A0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E4B40E-CBFD-37E1-8047-0485EA7A0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277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4F3E6B-2282-5484-8DC7-901ECC5307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CD14CB-6087-AC3B-6B26-74B1654243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9A2EE7-7DB0-4FE2-0C55-E13D05FF9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84A911-2AF2-7797-84D5-4F22AEC22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8211C5-D769-27CB-2D70-CBD44B883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7862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C0CDB2-F520-94E4-5293-2A7534D643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FE7D3F-0DAA-7353-449A-30D1B666F2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1D10FB-610E-6594-9CC6-58C780B8E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EF9DED-D9B5-0695-2284-F41860CCF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003C04-48F6-F821-FC28-E4B02CD63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970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6821EA-01D4-A77A-153A-6E155D26F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F34ECE-EE1F-9C5E-BDFB-90064481FB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10C144-F8A3-0504-D20C-1D4ED7B309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8F3C7-109B-E0E3-A910-B0A8EFDBC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E337F7-3CB0-83C3-FEEC-999602520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FEAA77-0111-A188-9D9A-9875607C7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02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EFCDC9-6CC5-B916-EB9E-F346A96AA7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544B87-1801-3B0D-AF58-30C1AAB04E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9E419D-6094-D2A3-19DD-C875616AE3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EF74A62-B69C-71C3-B583-88F1F6D0D8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BCAFA72-43F0-14A7-B941-61D56C7B9F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624595-4901-6CDA-B83E-10E0EF065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841CB20-2431-7698-521A-98787FEC5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17B753-4ADA-BF64-482D-B4B089A4E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898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E77F94-A4CA-1328-A668-AB1E5BF03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7253DD2-7C72-AE74-07EA-7274F764F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5F77EA-7E30-CCF8-F991-88D9DED4E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52AB3C-9633-4079-1752-EF25C86D3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107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4AC340-299B-74A9-4970-77678A640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A3FF993-1248-B27D-7A84-C3426452CD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0108D2-A073-2688-4E3B-FF6823075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531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822405-B66C-9658-5389-2FD49A2A13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D51A3C-A6D8-F07C-B214-D399594131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99BE42-CA31-A2BA-6955-949B81D41A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41343D-6209-ED06-1890-96A066692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072BF2-81EB-1535-362A-852632975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33B79B-034D-2A4C-B3A9-8EF136DF5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617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A7AA99-650B-051D-8277-3F802ACC97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84C0A8C-D35A-A030-0C92-A0779DE7AB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57F0FC-035C-9CB5-EE17-B0EB3B999A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2CBF11-6F1D-BB25-CC21-6D397F97D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994328-BE20-9DE1-581C-E4B6CE532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3CA18C-C28B-71BF-9097-0BD6FDF22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626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46754F-B12D-A053-A588-7896370F95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6F22A8-201A-3BA3-35AD-8770A6407C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980AA5-C7D1-A2DE-1FA9-50157FB687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A82EF-CB40-426B-9A64-77C94F52ACD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168303-CE77-54A3-11BC-78949433B5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EC43EB-6D12-A80E-0C07-CE3441FA3D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FCB17B-C146-4AAC-B87C-FB74AC14B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603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16872102-6718-98E9-2FAC-AF3856AE2FD4}"/>
              </a:ext>
            </a:extLst>
          </p:cNvPr>
          <p:cNvGrpSpPr/>
          <p:nvPr/>
        </p:nvGrpSpPr>
        <p:grpSpPr>
          <a:xfrm>
            <a:off x="968732" y="516494"/>
            <a:ext cx="10481145" cy="566182"/>
            <a:chOff x="968732" y="516494"/>
            <a:chExt cx="10481145" cy="566182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CF6A7900-C6F3-660D-7A5B-2B273D399C0F}"/>
                </a:ext>
              </a:extLst>
            </p:cNvPr>
            <p:cNvSpPr/>
            <p:nvPr/>
          </p:nvSpPr>
          <p:spPr>
            <a:xfrm>
              <a:off x="968732" y="516494"/>
              <a:ext cx="10481145" cy="566182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itle 1">
              <a:extLst>
                <a:ext uri="{FF2B5EF4-FFF2-40B4-BE49-F238E27FC236}">
                  <a16:creationId xmlns:a16="http://schemas.microsoft.com/office/drawing/2014/main" id="{6E41B97C-1774-9306-6472-816429DB23BE}"/>
                </a:ext>
              </a:extLst>
            </p:cNvPr>
            <p:cNvSpPr txBox="1">
              <a:spLocks noChangeArrowheads="1"/>
            </p:cNvSpPr>
            <p:nvPr/>
          </p:nvSpPr>
          <p:spPr>
            <a:xfrm>
              <a:off x="1922889" y="635763"/>
              <a:ext cx="8085815" cy="446913"/>
            </a:xfrm>
            <a:prstGeom prst="rect">
              <a:avLst/>
            </a:prstGeom>
          </p:spPr>
          <p:txBody>
            <a:bodyPr/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ctr"/>
              <a:r>
                <a:rPr lang="en-US" alt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l Table 1. TURBO TSI Limit of Quantitation (LOQ)</a:t>
              </a:r>
              <a:r>
                <a:rPr lang="en-US" altLang="en-US" sz="2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</p:grp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9AE011B-2C53-74C1-B3D5-192B918F4F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9215474"/>
              </p:ext>
            </p:extLst>
          </p:nvPr>
        </p:nvGraphicFramePr>
        <p:xfrm>
          <a:off x="968733" y="1082676"/>
          <a:ext cx="10481144" cy="369934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4256">
                  <a:extLst>
                    <a:ext uri="{9D8B030D-6E8A-4147-A177-3AD203B41FA5}">
                      <a16:colId xmlns:a16="http://schemas.microsoft.com/office/drawing/2014/main" val="2693283233"/>
                    </a:ext>
                  </a:extLst>
                </a:gridCol>
                <a:gridCol w="813192">
                  <a:extLst>
                    <a:ext uri="{9D8B030D-6E8A-4147-A177-3AD203B41FA5}">
                      <a16:colId xmlns:a16="http://schemas.microsoft.com/office/drawing/2014/main" val="617532012"/>
                    </a:ext>
                  </a:extLst>
                </a:gridCol>
                <a:gridCol w="542129">
                  <a:extLst>
                    <a:ext uri="{9D8B030D-6E8A-4147-A177-3AD203B41FA5}">
                      <a16:colId xmlns:a16="http://schemas.microsoft.com/office/drawing/2014/main" val="2996468453"/>
                    </a:ext>
                  </a:extLst>
                </a:gridCol>
                <a:gridCol w="1445675">
                  <a:extLst>
                    <a:ext uri="{9D8B030D-6E8A-4147-A177-3AD203B41FA5}">
                      <a16:colId xmlns:a16="http://schemas.microsoft.com/office/drawing/2014/main" val="53630629"/>
                    </a:ext>
                  </a:extLst>
                </a:gridCol>
                <a:gridCol w="1355320">
                  <a:extLst>
                    <a:ext uri="{9D8B030D-6E8A-4147-A177-3AD203B41FA5}">
                      <a16:colId xmlns:a16="http://schemas.microsoft.com/office/drawing/2014/main" val="3763722467"/>
                    </a:ext>
                  </a:extLst>
                </a:gridCol>
                <a:gridCol w="903547">
                  <a:extLst>
                    <a:ext uri="{9D8B030D-6E8A-4147-A177-3AD203B41FA5}">
                      <a16:colId xmlns:a16="http://schemas.microsoft.com/office/drawing/2014/main" val="3677469188"/>
                    </a:ext>
                  </a:extLst>
                </a:gridCol>
                <a:gridCol w="1264966">
                  <a:extLst>
                    <a:ext uri="{9D8B030D-6E8A-4147-A177-3AD203B41FA5}">
                      <a16:colId xmlns:a16="http://schemas.microsoft.com/office/drawing/2014/main" val="354099322"/>
                    </a:ext>
                  </a:extLst>
                </a:gridCol>
                <a:gridCol w="1174611">
                  <a:extLst>
                    <a:ext uri="{9D8B030D-6E8A-4147-A177-3AD203B41FA5}">
                      <a16:colId xmlns:a16="http://schemas.microsoft.com/office/drawing/2014/main" val="416854884"/>
                    </a:ext>
                  </a:extLst>
                </a:gridCol>
                <a:gridCol w="903547">
                  <a:extLst>
                    <a:ext uri="{9D8B030D-6E8A-4147-A177-3AD203B41FA5}">
                      <a16:colId xmlns:a16="http://schemas.microsoft.com/office/drawing/2014/main" val="1341771294"/>
                    </a:ext>
                  </a:extLst>
                </a:gridCol>
                <a:gridCol w="993901">
                  <a:extLst>
                    <a:ext uri="{9D8B030D-6E8A-4147-A177-3AD203B41FA5}">
                      <a16:colId xmlns:a16="http://schemas.microsoft.com/office/drawing/2014/main" val="4132320167"/>
                    </a:ext>
                  </a:extLst>
                </a:gridCol>
              </a:tblGrid>
              <a:tr h="86669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Kit Lot#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Sample ID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N</a:t>
                      </a:r>
                      <a:endParaRPr lang="en-US" sz="14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Average of Calculated Concentration (IU/L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solidFill>
                            <a:schemeClr val="tx1"/>
                          </a:solidFill>
                          <a:effectLst/>
                        </a:rPr>
                        <a:t>StdDev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 of Calculated Concentration (IU/L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%CV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Expected Concentration (IU/L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ABS Bias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TE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%TE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8651595"/>
                  </a:ext>
                </a:extLst>
              </a:tr>
              <a:tr h="283265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#231348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 0.020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 0.003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7.6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2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  0.007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 35.92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450428327"/>
                  </a:ext>
                </a:extLst>
              </a:tr>
              <a:tr h="2832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2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7.07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9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9.2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86736954"/>
                  </a:ext>
                </a:extLst>
              </a:tr>
              <a:tr h="2832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2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5.6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35.1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23024006"/>
                  </a:ext>
                </a:extLst>
              </a:tr>
              <a:tr h="2832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0.00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3.5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26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30.4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30488168"/>
                  </a:ext>
                </a:extLst>
              </a:tr>
              <a:tr h="2832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0.00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0.5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3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25.9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38651184"/>
                  </a:ext>
                </a:extLst>
              </a:tr>
              <a:tr h="283265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#231350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 0.021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17.15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2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  0.008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  41.63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071293867"/>
                  </a:ext>
                </a:extLst>
              </a:tr>
              <a:tr h="2832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0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5.77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2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37.29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33755651"/>
                  </a:ext>
                </a:extLst>
              </a:tr>
              <a:tr h="2832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20.5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0.00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1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41.2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8101679"/>
                  </a:ext>
                </a:extLst>
              </a:tr>
              <a:tr h="2832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4.0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02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0.00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0.008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30.4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50208593"/>
                  </a:ext>
                </a:extLst>
              </a:tr>
              <a:tr h="2832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29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1.1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03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.00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26.0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54284504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21B74D2-F183-E701-9B1A-762F53C5F072}"/>
              </a:ext>
            </a:extLst>
          </p:cNvPr>
          <p:cNvSpPr txBox="1"/>
          <p:nvPr/>
        </p:nvSpPr>
        <p:spPr>
          <a:xfrm>
            <a:off x="1100592" y="4901291"/>
            <a:ext cx="10217426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sz="2000" dirty="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The Turbo TSI Bioassay </a:t>
            </a:r>
            <a:r>
              <a:rPr lang="en-US" sz="2000" dirty="0" err="1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LoQ</a:t>
            </a:r>
            <a:r>
              <a:rPr lang="en-US" sz="2000" dirty="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is 0.021 IU/L, determined from the lowest sample concentration meeting accuracy criteria </a:t>
            </a:r>
            <a:r>
              <a:rPr lang="en-US" sz="2000" dirty="0">
                <a:solidFill>
                  <a:srgbClr val="374151"/>
                </a:solidFill>
                <a:latin typeface="Söhne"/>
                <a:cs typeface="Arial" panose="020B0604020202020204" pitchFamily="34" charset="0"/>
              </a:rPr>
              <a:t>(%TE ≤ 45%) </a:t>
            </a:r>
            <a:r>
              <a:rPr lang="en-US" sz="2000" dirty="0">
                <a:solidFill>
                  <a:srgbClr val="00000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in lots 231348 and 231350.</a:t>
            </a:r>
          </a:p>
        </p:txBody>
      </p:sp>
    </p:spTree>
    <p:extLst>
      <p:ext uri="{BB962C8B-B14F-4D97-AF65-F5344CB8AC3E}">
        <p14:creationId xmlns:p14="http://schemas.microsoft.com/office/powerpoint/2010/main" val="2869675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C0AE525-2718-7D96-591A-FD046D821185}"/>
              </a:ext>
            </a:extLst>
          </p:cNvPr>
          <p:cNvSpPr/>
          <p:nvPr/>
        </p:nvSpPr>
        <p:spPr>
          <a:xfrm>
            <a:off x="1506770" y="685800"/>
            <a:ext cx="8144127" cy="703078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66F50141-88D9-6908-30C6-13E5BF66CEDC}"/>
              </a:ext>
            </a:extLst>
          </p:cNvPr>
          <p:cNvSpPr txBox="1">
            <a:spLocks noChangeArrowheads="1"/>
          </p:cNvSpPr>
          <p:nvPr/>
        </p:nvSpPr>
        <p:spPr>
          <a:xfrm>
            <a:off x="1506770" y="839526"/>
            <a:ext cx="8237221" cy="43268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0. Turbo TSI: Incubation Temperature Range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36C35C6-EB1B-F205-5E7E-93E6DAE692BC}"/>
              </a:ext>
            </a:extLst>
          </p:cNvPr>
          <p:cNvGraphicFramePr>
            <a:graphicFrameLocks noGrp="1"/>
          </p:cNvGraphicFramePr>
          <p:nvPr/>
        </p:nvGraphicFramePr>
        <p:xfrm>
          <a:off x="1506771" y="1388878"/>
          <a:ext cx="8144126" cy="379935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38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9386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9454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454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9454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9454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9454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9454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9454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79454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361293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ample #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6">
                  <a:txBody>
                    <a:bodyPr/>
                    <a:lstStyle/>
                    <a:p>
                      <a:pPr algn="ctr" rtl="0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ncubation Temperature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vg</a:t>
                      </a:r>
                      <a:endParaRPr lang="en-US" sz="2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endParaRPr lang="en-US" sz="2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%CV</a:t>
                      </a:r>
                      <a:endParaRPr lang="en-US" sz="2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93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8°C</a:t>
                      </a:r>
                      <a:endParaRPr lang="en-US" sz="2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0°C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2°C</a:t>
                      </a:r>
                      <a:endParaRPr lang="en-US" sz="20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4°C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5°C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6°C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109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1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7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6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5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5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6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7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%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109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2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37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ECEAF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94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ECEAF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1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ECEAF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7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ECEAF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6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ECEAF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ECEAF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91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ECEAF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31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ECEAF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6%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ECEAF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109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3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06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83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46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88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41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284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7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0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9%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8109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4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21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832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53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187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864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214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141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61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%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8109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5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3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101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7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59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668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614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517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5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%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8109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-PC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.11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.402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.00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.057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.776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.772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.021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36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%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8109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-PC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34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355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279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34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4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41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361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54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%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8109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-PC</a:t>
                      </a:r>
                      <a:endParaRPr lang="en-US" sz="20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45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48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41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5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49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49</a:t>
                      </a:r>
                      <a:endParaRPr lang="en-US" sz="2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47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3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2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%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1FF4DDC-CAB2-0A9E-1582-5FC8AD64966A}"/>
              </a:ext>
            </a:extLst>
          </p:cNvPr>
          <p:cNvSpPr txBox="1"/>
          <p:nvPr/>
        </p:nvSpPr>
        <p:spPr>
          <a:xfrm>
            <a:off x="1659834" y="5304898"/>
            <a:ext cx="6160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-PC, M-PC, L-PC: high, medium and low positive control.</a:t>
            </a:r>
          </a:p>
        </p:txBody>
      </p:sp>
    </p:spTree>
    <p:extLst>
      <p:ext uri="{BB962C8B-B14F-4D97-AF65-F5344CB8AC3E}">
        <p14:creationId xmlns:p14="http://schemas.microsoft.com/office/powerpoint/2010/main" val="3848726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8F081C2-9281-3662-5C0D-BE0C717E1D70}"/>
              </a:ext>
            </a:extLst>
          </p:cNvPr>
          <p:cNvSpPr/>
          <p:nvPr/>
        </p:nvSpPr>
        <p:spPr>
          <a:xfrm>
            <a:off x="1752600" y="675861"/>
            <a:ext cx="8258092" cy="656824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BA91261A-E202-4115-9534-1C07D83C19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8740" y="799285"/>
            <a:ext cx="8040756" cy="533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lnSpc>
                <a:spcPct val="110000"/>
              </a:lnSpc>
              <a:spcBef>
                <a:spcPts val="675"/>
              </a:spcBef>
              <a:buClr>
                <a:schemeClr val="tx1"/>
              </a:buClr>
              <a:buFont typeface="Verdana" panose="020B0604030504040204" pitchFamily="34" charset="0"/>
              <a:buChar char="▪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1pPr>
            <a:lvl2pPr marL="23812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2pPr>
            <a:lvl3pPr marL="376238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3pPr>
            <a:lvl4pPr marL="514350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4pPr>
            <a:lvl5pPr marL="65087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5pPr>
            <a:lvl6pPr marL="11080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6pPr>
            <a:lvl7pPr marL="15652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7pPr>
            <a:lvl8pPr marL="20224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8pPr>
            <a:lvl9pPr marL="24796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None/>
            </a:pPr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URBO TSI: Cross-reactivity of human sera</a:t>
            </a:r>
          </a:p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None/>
            </a:pPr>
            <a:endParaRPr lang="en-US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19190817-59C1-76D7-86F3-C489D2334185}"/>
              </a:ext>
            </a:extLst>
          </p:cNvPr>
          <p:cNvGraphicFramePr>
            <a:graphicFrameLocks noGrp="1"/>
          </p:cNvGraphicFramePr>
          <p:nvPr/>
        </p:nvGraphicFramePr>
        <p:xfrm>
          <a:off x="1752600" y="1332685"/>
          <a:ext cx="8258092" cy="4333964"/>
        </p:xfrm>
        <a:graphic>
          <a:graphicData uri="http://schemas.openxmlformats.org/drawingml/2006/table">
            <a:tbl>
              <a:tblPr/>
              <a:tblGrid>
                <a:gridCol w="35507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6700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403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0390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Antibody/Disease</a:t>
                      </a:r>
                      <a:endParaRPr kumimoji="0" lang="en-US" altLang="en-US" sz="1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kumimoji="0" lang="en-US" altLang="en-US" sz="1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ercent </a:t>
                      </a:r>
                      <a:r>
                        <a:rPr kumimoji="0" lang="en-US" altLang="en-US" sz="1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 Cutoff</a:t>
                      </a:r>
                      <a:endParaRPr kumimoji="0" lang="en-US" altLang="en-US" sz="1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uman anti-mouse antibody 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Rheumatoid Factor (RF)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nti-</a:t>
                      </a:r>
                      <a:r>
                        <a:rPr kumimoji="0" lang="en-US" altLang="en-US" sz="1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thyroperoxidase</a:t>
                      </a: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(TPO)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nti-thyroglobulin (TG)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Rheumatoid Arthritis</a:t>
                      </a:r>
                      <a:endParaRPr kumimoji="0" lang="en-US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Systemic lupus erythematosus 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Type 1 Diabetes Mellitus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5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Celiac Disease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96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49576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regnancy: Hypertension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regnancy: Preeclampsia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14381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Thyroid Cancer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81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36678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ashimoto's Disease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2D0DAA3-CF49-E1F8-D11B-F37761CD780F}"/>
              </a:ext>
            </a:extLst>
          </p:cNvPr>
          <p:cNvSpPr txBox="1"/>
          <p:nvPr/>
        </p:nvSpPr>
        <p:spPr>
          <a:xfrm>
            <a:off x="2004391" y="5735549"/>
            <a:ext cx="74974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erum samples were tested in the Turbo TSI assay and the percentage of sera that were below the assay cut-off (</a:t>
            </a:r>
            <a:r>
              <a:rPr lang="en-US" sz="1800" kern="5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0.0241 IU/L) is indicated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7012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5123B4B-9D28-C1EF-96FE-AC0D8F9DC00A}"/>
              </a:ext>
            </a:extLst>
          </p:cNvPr>
          <p:cNvSpPr/>
          <p:nvPr/>
        </p:nvSpPr>
        <p:spPr>
          <a:xfrm>
            <a:off x="1292087" y="111639"/>
            <a:ext cx="9064487" cy="489375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F427700B-26A7-05DA-7B45-18BA2CC373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44486" y="229527"/>
            <a:ext cx="9150627" cy="489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lnSpc>
                <a:spcPct val="110000"/>
              </a:lnSpc>
              <a:spcBef>
                <a:spcPts val="675"/>
              </a:spcBef>
              <a:buClr>
                <a:schemeClr val="tx1"/>
              </a:buClr>
              <a:buFont typeface="Verdana" panose="020B0604030504040204" pitchFamily="34" charset="0"/>
              <a:buChar char="▪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1pPr>
            <a:lvl2pPr marL="23812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2pPr>
            <a:lvl3pPr marL="376238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3pPr>
            <a:lvl4pPr marL="514350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4pPr>
            <a:lvl5pPr marL="65087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5pPr>
            <a:lvl6pPr marL="11080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6pPr>
            <a:lvl7pPr marL="15652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7pPr>
            <a:lvl8pPr marL="20224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8pPr>
            <a:lvl9pPr marL="24796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None/>
            </a:pPr>
            <a:r>
              <a:rPr lang="en-US" alt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3. TURBO TSI: Interference by Blood Components and Drugs</a:t>
            </a:r>
          </a:p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None/>
            </a:pPr>
            <a:endParaRPr lang="en-US" altLang="en-US" sz="2400" b="1" dirty="0">
              <a:solidFill>
                <a:srgbClr val="774DEF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E322A19-D226-6395-B947-529F4C59C42C}"/>
              </a:ext>
            </a:extLst>
          </p:cNvPr>
          <p:cNvGraphicFramePr>
            <a:graphicFrameLocks noGrp="1"/>
          </p:cNvGraphicFramePr>
          <p:nvPr/>
        </p:nvGraphicFramePr>
        <p:xfrm>
          <a:off x="1292085" y="601014"/>
          <a:ext cx="9064486" cy="557118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010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437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6361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5605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754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fering substance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centration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rbo TSI (IU/L) </a:t>
                      </a:r>
                    </a:p>
                  </a:txBody>
                  <a:tcPr marL="9525" marR="9525" marT="9523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Control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oglobin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mg/d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0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irubin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mg/d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2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teinizing hormone (LH)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 IU/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yroid-stimulating hormone (TSH)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 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U</a:t>
                      </a: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9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3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licle-stimulating hormone (FSH)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 IU/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3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horionic gonadotropin (</a:t>
                      </a:r>
                      <a:r>
                        <a:rPr lang="en-US" sz="14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G</a:t>
                      </a:r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,000 IU/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9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radiol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 n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gesterone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7</a:t>
                      </a:r>
                      <a:endParaRPr lang="en-US" sz="14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.7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actin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vothyroxine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8</a:t>
                      </a:r>
                      <a:endParaRPr lang="en-US" sz="14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6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othyronine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leno</a:t>
                      </a:r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L-methionine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.0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651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propyl-2-thiouracil)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3.2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thium carbonate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interferon-alpha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 n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interleukin-2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1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ilimumab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0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mtuzumab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4 µg/mL</a:t>
                      </a:r>
                      <a:endParaRPr lang="en-US" sz="14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40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dine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.6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6591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nitinib malate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 mg/mL</a:t>
                      </a:r>
                      <a:endParaRPr lang="en-US" sz="14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7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2.1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3374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atinib mesylate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µg/mL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8%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3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2BDA7FC-BF01-445D-86A6-C9953FEF6D34}"/>
              </a:ext>
            </a:extLst>
          </p:cNvPr>
          <p:cNvSpPr txBox="1"/>
          <p:nvPr/>
        </p:nvSpPr>
        <p:spPr>
          <a:xfrm>
            <a:off x="1263922" y="6162255"/>
            <a:ext cx="93311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dirty="0">
                <a:solidFill>
                  <a:schemeClr val="tx2"/>
                </a:solidFill>
                <a:cs typeface="Times New Roman" panose="02020603050405020304" pitchFamily="18" charset="0"/>
              </a:rPr>
              <a:t>Each substance was added at the indicated concentration to a low-positive TSI serum (0.233 IU/L). The percentage change is relative to the TSI-positive serum alone (control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68267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F9970FFE-0242-3989-74B9-0893D14F3C6E}"/>
              </a:ext>
            </a:extLst>
          </p:cNvPr>
          <p:cNvGrpSpPr/>
          <p:nvPr/>
        </p:nvGrpSpPr>
        <p:grpSpPr>
          <a:xfrm>
            <a:off x="1848678" y="370311"/>
            <a:ext cx="7292178" cy="593788"/>
            <a:chOff x="1848678" y="298178"/>
            <a:chExt cx="7533861" cy="697186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A1F3B2F0-E7BB-585F-C129-773895CBF342}"/>
                </a:ext>
              </a:extLst>
            </p:cNvPr>
            <p:cNvSpPr/>
            <p:nvPr/>
          </p:nvSpPr>
          <p:spPr>
            <a:xfrm>
              <a:off x="1848678" y="298178"/>
              <a:ext cx="7533861" cy="606286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itle 1">
              <a:extLst>
                <a:ext uri="{FF2B5EF4-FFF2-40B4-BE49-F238E27FC236}">
                  <a16:creationId xmlns:a16="http://schemas.microsoft.com/office/drawing/2014/main" id="{2731C804-7B4A-F044-2B24-D87A09CFD77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30287" y="461964"/>
              <a:ext cx="6924261" cy="533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lnSpc>
                  <a:spcPct val="110000"/>
                </a:lnSpc>
                <a:spcBef>
                  <a:spcPts val="675"/>
                </a:spcBef>
                <a:buClr>
                  <a:schemeClr val="tx1"/>
                </a:buClr>
                <a:buFont typeface="Verdana" panose="020B0604030504040204" pitchFamily="34" charset="0"/>
                <a:buChar char="▪"/>
                <a:defRPr sz="1100">
                  <a:solidFill>
                    <a:schemeClr val="tx1"/>
                  </a:solidFill>
                  <a:latin typeface="Verdana" panose="020B0604030504040204" pitchFamily="34" charset="0"/>
                </a:defRPr>
              </a:lvl1pPr>
              <a:lvl2pPr marL="238125" indent="-136525">
                <a:lnSpc>
                  <a:spcPct val="110000"/>
                </a:lnSpc>
                <a:spcBef>
                  <a:spcPts val="225"/>
                </a:spcBef>
                <a:buFont typeface="Verdana" panose="020B0604030504040204" pitchFamily="34" charset="0"/>
                <a:buChar char="–"/>
                <a:defRPr sz="1100">
                  <a:solidFill>
                    <a:schemeClr val="tx1"/>
                  </a:solidFill>
                  <a:latin typeface="Verdana" panose="020B0604030504040204" pitchFamily="34" charset="0"/>
                </a:defRPr>
              </a:lvl2pPr>
              <a:lvl3pPr marL="376238" indent="-136525">
                <a:lnSpc>
                  <a:spcPct val="110000"/>
                </a:lnSpc>
                <a:spcBef>
                  <a:spcPts val="225"/>
                </a:spcBef>
                <a:buFont typeface="Verdana" panose="020B0604030504040204" pitchFamily="34" charset="0"/>
                <a:buChar char="–"/>
                <a:defRPr sz="1100">
                  <a:solidFill>
                    <a:schemeClr val="tx1"/>
                  </a:solidFill>
                  <a:latin typeface="Verdana" panose="020B0604030504040204" pitchFamily="34" charset="0"/>
                </a:defRPr>
              </a:lvl3pPr>
              <a:lvl4pPr marL="514350" indent="-136525">
                <a:lnSpc>
                  <a:spcPct val="110000"/>
                </a:lnSpc>
                <a:spcBef>
                  <a:spcPts val="225"/>
                </a:spcBef>
                <a:buFont typeface="Verdana" panose="020B0604030504040204" pitchFamily="34" charset="0"/>
                <a:buChar char="–"/>
                <a:defRPr sz="1100">
                  <a:solidFill>
                    <a:schemeClr val="tx1"/>
                  </a:solidFill>
                  <a:latin typeface="Verdana" panose="020B0604030504040204" pitchFamily="34" charset="0"/>
                </a:defRPr>
              </a:lvl4pPr>
              <a:lvl5pPr marL="650875" indent="-136525">
                <a:lnSpc>
                  <a:spcPct val="110000"/>
                </a:lnSpc>
                <a:spcBef>
                  <a:spcPts val="225"/>
                </a:spcBef>
                <a:buFont typeface="Verdana" panose="020B0604030504040204" pitchFamily="34" charset="0"/>
                <a:buChar char="–"/>
                <a:defRPr sz="1100">
                  <a:solidFill>
                    <a:schemeClr val="tx1"/>
                  </a:solidFill>
                  <a:latin typeface="Verdana" panose="020B0604030504040204" pitchFamily="34" charset="0"/>
                </a:defRPr>
              </a:lvl5pPr>
              <a:lvl6pPr marL="1108075" indent="-136525" eaLnBrk="0" fontAlgn="base" hangingPunct="0">
                <a:lnSpc>
                  <a:spcPct val="110000"/>
                </a:lnSpc>
                <a:spcBef>
                  <a:spcPts val="225"/>
                </a:spcBef>
                <a:spcAft>
                  <a:spcPct val="0"/>
                </a:spcAft>
                <a:buFont typeface="Verdana" panose="020B0604030504040204" pitchFamily="34" charset="0"/>
                <a:buChar char="–"/>
                <a:defRPr sz="1100">
                  <a:solidFill>
                    <a:schemeClr val="tx1"/>
                  </a:solidFill>
                  <a:latin typeface="Verdana" panose="020B0604030504040204" pitchFamily="34" charset="0"/>
                </a:defRPr>
              </a:lvl6pPr>
              <a:lvl7pPr marL="1565275" indent="-136525" eaLnBrk="0" fontAlgn="base" hangingPunct="0">
                <a:lnSpc>
                  <a:spcPct val="110000"/>
                </a:lnSpc>
                <a:spcBef>
                  <a:spcPts val="225"/>
                </a:spcBef>
                <a:spcAft>
                  <a:spcPct val="0"/>
                </a:spcAft>
                <a:buFont typeface="Verdana" panose="020B0604030504040204" pitchFamily="34" charset="0"/>
                <a:buChar char="–"/>
                <a:defRPr sz="1100">
                  <a:solidFill>
                    <a:schemeClr val="tx1"/>
                  </a:solidFill>
                  <a:latin typeface="Verdana" panose="020B0604030504040204" pitchFamily="34" charset="0"/>
                </a:defRPr>
              </a:lvl7pPr>
              <a:lvl8pPr marL="2022475" indent="-136525" eaLnBrk="0" fontAlgn="base" hangingPunct="0">
                <a:lnSpc>
                  <a:spcPct val="110000"/>
                </a:lnSpc>
                <a:spcBef>
                  <a:spcPts val="225"/>
                </a:spcBef>
                <a:spcAft>
                  <a:spcPct val="0"/>
                </a:spcAft>
                <a:buFont typeface="Verdana" panose="020B0604030504040204" pitchFamily="34" charset="0"/>
                <a:buChar char="–"/>
                <a:defRPr sz="1100">
                  <a:solidFill>
                    <a:schemeClr val="tx1"/>
                  </a:solidFill>
                  <a:latin typeface="Verdana" panose="020B0604030504040204" pitchFamily="34" charset="0"/>
                </a:defRPr>
              </a:lvl8pPr>
              <a:lvl9pPr marL="2479675" indent="-136525" eaLnBrk="0" fontAlgn="base" hangingPunct="0">
                <a:lnSpc>
                  <a:spcPct val="110000"/>
                </a:lnSpc>
                <a:spcBef>
                  <a:spcPts val="225"/>
                </a:spcBef>
                <a:spcAft>
                  <a:spcPct val="0"/>
                </a:spcAft>
                <a:buFont typeface="Verdana" panose="020B0604030504040204" pitchFamily="34" charset="0"/>
                <a:buChar char="–"/>
                <a:defRPr sz="1100">
                  <a:solidFill>
                    <a:schemeClr val="tx1"/>
                  </a:solidFill>
                  <a:latin typeface="Verdana" panose="020B0604030504040204" pitchFamily="34" charset="0"/>
                </a:defRPr>
              </a:lvl9pPr>
            </a:lstStyle>
            <a:p>
              <a:pPr fontAlgn="base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None/>
              </a:pPr>
              <a:r>
                <a:rPr lang="en-US" altLang="en-US" sz="2000" b="1" dirty="0">
                  <a:latin typeface="+mn-lt"/>
                  <a:cs typeface="Calibri" panose="020F0502020204030204" pitchFamily="34" charset="0"/>
                </a:rPr>
                <a:t>Supplemental Table 4. TURBO TSI: </a:t>
              </a:r>
              <a:r>
                <a:rPr lang="en-US" altLang="en-US" sz="2000" b="1" dirty="0">
                  <a:latin typeface="+mn-lt"/>
                  <a:cs typeface="Arial" panose="020B0604020202020204" pitchFamily="34" charset="0"/>
                </a:rPr>
                <a:t>Interference by Human Sera</a:t>
              </a:r>
            </a:p>
            <a:p>
              <a:pPr fontAlgn="base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None/>
              </a:pPr>
              <a:endParaRPr lang="en-US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871177DF-10E5-7CF7-B1B6-1684D3ACC4E1}"/>
              </a:ext>
            </a:extLst>
          </p:cNvPr>
          <p:cNvGraphicFramePr>
            <a:graphicFrameLocks noGrp="1"/>
          </p:cNvGraphicFramePr>
          <p:nvPr/>
        </p:nvGraphicFramePr>
        <p:xfrm>
          <a:off x="1848678" y="904464"/>
          <a:ext cx="7292178" cy="4949681"/>
        </p:xfrm>
        <a:graphic>
          <a:graphicData uri="http://schemas.openxmlformats.org/drawingml/2006/table">
            <a:tbl>
              <a:tblPr/>
              <a:tblGrid>
                <a:gridCol w="373267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4861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1089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64665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Serum</a:t>
                      </a:r>
                      <a:endParaRPr kumimoji="0" lang="en-US" altLang="en-US" sz="1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kumimoji="0" lang="en-US" altLang="en-US" sz="1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% </a:t>
                      </a:r>
                      <a:r>
                        <a:rPr kumimoji="0" lang="en-US" altLang="en-US" sz="18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&gt;0.178 IU/L</a:t>
                      </a:r>
                      <a:endParaRPr kumimoji="0" lang="en-US" altLang="en-US" sz="18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uman anti-mouse antibody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Rheumatoid factor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nti-TPO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Anti-thyroglobulin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Arial" panose="020B0604020202020204" pitchFamily="34" charset="0"/>
                        </a:rPr>
                        <a:t>Rheumatoid Arthritis</a:t>
                      </a:r>
                      <a:endParaRPr kumimoji="0" lang="en-US" alt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Systemic lupus erythematosus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Type 1 Diabetes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Gliadin Ab IgA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23062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Transglutaminase IgA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Celiac Disease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Pregnancy: Preeclampsia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Thyroid Cancer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23330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Hashimoto’s Disease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37592" marR="37592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Clr>
                          <a:srgbClr val="95B3D7"/>
                        </a:buClr>
                        <a:buFont typeface="Wingdings" panose="05000000000000000000" pitchFamily="2" charset="2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Wingdings" panose="05000000000000000000" pitchFamily="2" charset="2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Wingdings" panose="05000000000000000000" pitchFamily="2" charset="2"/>
                        <a:defRPr sz="160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100 %</a:t>
                      </a:r>
                    </a:p>
                  </a:txBody>
                  <a:tcPr marL="51435" marR="51435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1E75E70-D688-DB8C-73D9-4AF9A52D43D2}"/>
              </a:ext>
            </a:extLst>
          </p:cNvPr>
          <p:cNvSpPr txBox="1"/>
          <p:nvPr/>
        </p:nvSpPr>
        <p:spPr>
          <a:xfrm>
            <a:off x="1952850" y="5953536"/>
            <a:ext cx="72921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dirty="0">
                <a:solidFill>
                  <a:schemeClr val="tx2"/>
                </a:solidFill>
              </a:rPr>
              <a:t>Serum samples were added to a low TSI positive serum (0.178 IU/L) and the percentage of the serum with IU/L above 0.178 IU/L are indicated.</a:t>
            </a:r>
          </a:p>
        </p:txBody>
      </p:sp>
    </p:spTree>
    <p:extLst>
      <p:ext uri="{BB962C8B-B14F-4D97-AF65-F5344CB8AC3E}">
        <p14:creationId xmlns:p14="http://schemas.microsoft.com/office/powerpoint/2010/main" val="7068878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D5B0A19-247F-834A-4D00-079B5EE031C1}"/>
              </a:ext>
            </a:extLst>
          </p:cNvPr>
          <p:cNvSpPr/>
          <p:nvPr/>
        </p:nvSpPr>
        <p:spPr>
          <a:xfrm>
            <a:off x="1398356" y="717402"/>
            <a:ext cx="9395288" cy="575407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574927AE-16BA-346C-C8C6-C9DBD4A572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5430" y="804431"/>
            <a:ext cx="5580821" cy="4013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lnSpc>
                <a:spcPct val="110000"/>
              </a:lnSpc>
              <a:spcBef>
                <a:spcPts val="675"/>
              </a:spcBef>
              <a:buClr>
                <a:schemeClr val="tx1"/>
              </a:buClr>
              <a:buFont typeface="Verdana" panose="020B0604030504040204" pitchFamily="34" charset="0"/>
              <a:buChar char="▪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1pPr>
            <a:lvl2pPr marL="23812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2pPr>
            <a:lvl3pPr marL="376238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3pPr>
            <a:lvl4pPr marL="514350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4pPr>
            <a:lvl5pPr marL="65087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5pPr>
            <a:lvl6pPr marL="11080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6pPr>
            <a:lvl7pPr marL="15652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7pPr>
            <a:lvl8pPr marL="20224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8pPr>
            <a:lvl9pPr marL="24796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None/>
            </a:pPr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altLang="en-US" sz="2000" b="1">
                <a:latin typeface="Arial" panose="020B0604020202020204" pitchFamily="34" charset="0"/>
                <a:cs typeface="Arial" panose="020B0604020202020204" pitchFamily="34" charset="0"/>
              </a:rPr>
              <a:t>Table 5. </a:t>
            </a:r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URBO TSI: Linearity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4A99EFF8-AA89-D55E-6FA1-614226414AE6}"/>
              </a:ext>
            </a:extLst>
          </p:cNvPr>
          <p:cNvGraphicFramePr>
            <a:graphicFrameLocks noGrp="1"/>
          </p:cNvGraphicFramePr>
          <p:nvPr/>
        </p:nvGraphicFramePr>
        <p:xfrm>
          <a:off x="1398356" y="1292809"/>
          <a:ext cx="9395288" cy="471977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68811">
                  <a:extLst>
                    <a:ext uri="{9D8B030D-6E8A-4147-A177-3AD203B41FA5}">
                      <a16:colId xmlns:a16="http://schemas.microsoft.com/office/drawing/2014/main" val="3815691604"/>
                    </a:ext>
                  </a:extLst>
                </a:gridCol>
                <a:gridCol w="1085046">
                  <a:extLst>
                    <a:ext uri="{9D8B030D-6E8A-4147-A177-3AD203B41FA5}">
                      <a16:colId xmlns:a16="http://schemas.microsoft.com/office/drawing/2014/main" val="3562806446"/>
                    </a:ext>
                  </a:extLst>
                </a:gridCol>
                <a:gridCol w="1446403">
                  <a:extLst>
                    <a:ext uri="{9D8B030D-6E8A-4147-A177-3AD203B41FA5}">
                      <a16:colId xmlns:a16="http://schemas.microsoft.com/office/drawing/2014/main" val="3150597769"/>
                    </a:ext>
                  </a:extLst>
                </a:gridCol>
                <a:gridCol w="1536985">
                  <a:extLst>
                    <a:ext uri="{9D8B030D-6E8A-4147-A177-3AD203B41FA5}">
                      <a16:colId xmlns:a16="http://schemas.microsoft.com/office/drawing/2014/main" val="1744932338"/>
                    </a:ext>
                  </a:extLst>
                </a:gridCol>
                <a:gridCol w="1446403">
                  <a:extLst>
                    <a:ext uri="{9D8B030D-6E8A-4147-A177-3AD203B41FA5}">
                      <a16:colId xmlns:a16="http://schemas.microsoft.com/office/drawing/2014/main" val="3156746912"/>
                    </a:ext>
                  </a:extLst>
                </a:gridCol>
                <a:gridCol w="1265237">
                  <a:extLst>
                    <a:ext uri="{9D8B030D-6E8A-4147-A177-3AD203B41FA5}">
                      <a16:colId xmlns:a16="http://schemas.microsoft.com/office/drawing/2014/main" val="3908560097"/>
                    </a:ext>
                  </a:extLst>
                </a:gridCol>
                <a:gridCol w="1446403">
                  <a:extLst>
                    <a:ext uri="{9D8B030D-6E8A-4147-A177-3AD203B41FA5}">
                      <a16:colId xmlns:a16="http://schemas.microsoft.com/office/drawing/2014/main" val="3070837186"/>
                    </a:ext>
                  </a:extLst>
                </a:gridCol>
              </a:tblGrid>
              <a:tr h="45085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Sample ID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Sample Size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Expected Conc (IU/L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Calculated Conc (IU/L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Predicted Value (IU/L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eviation (IU/L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% Deviation (ADL)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92701919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2.000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1.72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1.95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23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2.0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87613565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1.25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1.08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1.21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12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1.1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32618261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0.50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0.42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0.46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04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4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2352159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0.12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0.26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0.09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17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.7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33244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effectLst/>
                        </a:rPr>
                        <a:t>9.754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0.450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9.719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73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7.5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6888911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6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9.00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9.54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8.97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57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6.4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03902682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7.50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effectLst/>
                        </a:rPr>
                        <a:t>8.214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7.479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73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9.8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77109482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6.010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5.940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effectLst/>
                        </a:rPr>
                        <a:t>5.986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04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8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5179192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9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4.51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4.61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effectLst/>
                        </a:rPr>
                        <a:t>4.493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120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2.7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30923765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10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3.01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2.959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3.00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04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1.4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3951614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1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.51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.37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1.50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effectLst/>
                        </a:rPr>
                        <a:t>-0.134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8.9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28020724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1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76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70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76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05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7.1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60955785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1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39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37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38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010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effectLst/>
                        </a:rPr>
                        <a:t>-2.6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54488139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1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206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199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20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00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1.2%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90232000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1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11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10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10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-0.006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effectLst/>
                        </a:rPr>
                        <a:t>-5.7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96184849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16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03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03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03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00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effectLst/>
                        </a:rPr>
                        <a:t>2.9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11736869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D17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019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01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01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>
                          <a:effectLst/>
                        </a:rPr>
                        <a:t>0.000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effectLst/>
                        </a:rPr>
                        <a:t>0.1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1905026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E182E87-0687-8A01-FD6C-8FE6170151DB}"/>
              </a:ext>
            </a:extLst>
          </p:cNvPr>
          <p:cNvSpPr txBox="1"/>
          <p:nvPr/>
        </p:nvSpPr>
        <p:spPr>
          <a:xfrm>
            <a:off x="1398356" y="6053569"/>
            <a:ext cx="93952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ve replicates of fifteen samples of TSI-positive serum with concentrations from just below the cut-off (0.019 IU/L) to 500 times the cut-off (12.00 IU/L) were tested and the deviation from the predicted value and the average percent deviation from linearity (ADL) were calculated.</a:t>
            </a:r>
          </a:p>
        </p:txBody>
      </p:sp>
    </p:spTree>
    <p:extLst>
      <p:ext uri="{BB962C8B-B14F-4D97-AF65-F5344CB8AC3E}">
        <p14:creationId xmlns:p14="http://schemas.microsoft.com/office/powerpoint/2010/main" val="445284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C6EE353-9769-C518-5F0F-8C0EB5E23549}"/>
              </a:ext>
            </a:extLst>
          </p:cNvPr>
          <p:cNvSpPr/>
          <p:nvPr/>
        </p:nvSpPr>
        <p:spPr>
          <a:xfrm>
            <a:off x="2002031" y="705678"/>
            <a:ext cx="7809878" cy="655983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318CF767-2F00-3C1A-4355-F0A13202AB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3682" y="857794"/>
            <a:ext cx="8396287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lnSpc>
                <a:spcPct val="110000"/>
              </a:lnSpc>
              <a:spcBef>
                <a:spcPts val="675"/>
              </a:spcBef>
              <a:buClr>
                <a:schemeClr val="tx1"/>
              </a:buClr>
              <a:buFont typeface="Verdana" panose="020B0604030504040204" pitchFamily="34" charset="0"/>
              <a:buChar char="▪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1pPr>
            <a:lvl2pPr marL="23812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2pPr>
            <a:lvl3pPr marL="376238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3pPr>
            <a:lvl4pPr marL="514350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4pPr>
            <a:lvl5pPr marL="65087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5pPr>
            <a:lvl6pPr marL="11080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6pPr>
            <a:lvl7pPr marL="15652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7pPr>
            <a:lvl8pPr marL="20224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8pPr>
            <a:lvl9pPr marL="24796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9pPr>
          </a:lstStyle>
          <a:p>
            <a:pPr algn="ctr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None/>
            </a:pPr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6. Turbo TSI Sample Stability</a:t>
            </a:r>
            <a:endParaRPr lang="en-US" altLang="en-US" sz="20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1D92021F-9F44-3A9E-6D6C-E30FCC8746D7}"/>
              </a:ext>
            </a:extLst>
          </p:cNvPr>
          <p:cNvGraphicFramePr>
            <a:graphicFrameLocks noGrp="1"/>
          </p:cNvGraphicFramePr>
          <p:nvPr/>
        </p:nvGraphicFramePr>
        <p:xfrm>
          <a:off x="2002031" y="1282968"/>
          <a:ext cx="7809878" cy="46634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90438">
                  <a:extLst>
                    <a:ext uri="{9D8B030D-6E8A-4147-A177-3AD203B41FA5}">
                      <a16:colId xmlns:a16="http://schemas.microsoft.com/office/drawing/2014/main" val="2802188226"/>
                    </a:ext>
                  </a:extLst>
                </a:gridCol>
                <a:gridCol w="1126662">
                  <a:extLst>
                    <a:ext uri="{9D8B030D-6E8A-4147-A177-3AD203B41FA5}">
                      <a16:colId xmlns:a16="http://schemas.microsoft.com/office/drawing/2014/main" val="53928088"/>
                    </a:ext>
                  </a:extLst>
                </a:gridCol>
                <a:gridCol w="3353157">
                  <a:extLst>
                    <a:ext uri="{9D8B030D-6E8A-4147-A177-3AD203B41FA5}">
                      <a16:colId xmlns:a16="http://schemas.microsoft.com/office/drawing/2014/main" val="1481093107"/>
                    </a:ext>
                  </a:extLst>
                </a:gridCol>
                <a:gridCol w="1439621">
                  <a:extLst>
                    <a:ext uri="{9D8B030D-6E8A-4147-A177-3AD203B41FA5}">
                      <a16:colId xmlns:a16="http://schemas.microsoft.com/office/drawing/2014/main" val="1734689541"/>
                    </a:ext>
                  </a:extLst>
                </a:gridCol>
              </a:tblGrid>
              <a:tr h="38508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torage Temperature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ample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verage TSI Concentration (IU/L)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%CV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7010581"/>
                  </a:ext>
                </a:extLst>
              </a:tr>
              <a:tr h="233570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5 °C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45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9%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8983872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6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3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5698685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986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1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4676085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96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62358473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.12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2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53907963"/>
                  </a:ext>
                </a:extLst>
              </a:tr>
              <a:tr h="233570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 °C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42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2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10871037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64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5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42565775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971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0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3858779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958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6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97811028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.10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1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43796509"/>
                  </a:ext>
                </a:extLst>
              </a:tr>
              <a:tr h="233570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0 °C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35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3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01765581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5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5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0824276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11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2%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26840991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137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0%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63869493"/>
                  </a:ext>
                </a:extLst>
              </a:tr>
              <a:tr h="23357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.12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6%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6675006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1507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362DB9A3-A394-1E74-DF49-352C37B1FC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33675" y="644350"/>
            <a:ext cx="8396287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lnSpc>
                <a:spcPct val="110000"/>
              </a:lnSpc>
              <a:spcBef>
                <a:spcPts val="675"/>
              </a:spcBef>
              <a:buClr>
                <a:schemeClr val="tx1"/>
              </a:buClr>
              <a:buFont typeface="Verdana" panose="020B0604030504040204" pitchFamily="34" charset="0"/>
              <a:buChar char="▪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1pPr>
            <a:lvl2pPr marL="23812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2pPr>
            <a:lvl3pPr marL="376238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3pPr>
            <a:lvl4pPr marL="514350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4pPr>
            <a:lvl5pPr marL="65087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5pPr>
            <a:lvl6pPr marL="11080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6pPr>
            <a:lvl7pPr marL="15652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7pPr>
            <a:lvl8pPr marL="20224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8pPr>
            <a:lvl9pPr marL="24796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9pPr>
          </a:lstStyle>
          <a:p>
            <a:pPr algn="ctr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None/>
            </a:pPr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7. Turbo TSI: Sample Cold Temperature Stability 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B9C269E-B223-71AF-5816-9ADD71236B64}"/>
              </a:ext>
            </a:extLst>
          </p:cNvPr>
          <p:cNvGraphicFramePr>
            <a:graphicFrameLocks noGrp="1"/>
          </p:cNvGraphicFramePr>
          <p:nvPr/>
        </p:nvGraphicFramePr>
        <p:xfrm>
          <a:off x="1904998" y="1193799"/>
          <a:ext cx="8224964" cy="467750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9200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087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0626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65713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6079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7070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torage Temperature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ample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verage TSI Concentration (IU/L)</a:t>
                      </a:r>
                      <a:endParaRPr lang="en-US" sz="1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uration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%CV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5355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 4°C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04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weeks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%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0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week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3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9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week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21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week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 sz="11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055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week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%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5355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20°C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0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month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99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month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3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6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month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4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06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month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731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3 months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5355">
                <a:tc rowSpan="5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70°C</a:t>
                      </a:r>
                      <a:endParaRPr lang="en-US" sz="1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0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14 month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-70°C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Batang" panose="02030600000101010101" pitchFamily="18" charset="-127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9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14 months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8838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3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6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14 months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%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10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14 month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%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3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5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88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-14 months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%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Batang" panose="02030600000101010101" pitchFamily="18" charset="-127"/>
                        <a:cs typeface="Calibri" panose="020F0502020204030204" pitchFamily="34" charset="0"/>
                      </a:endParaRPr>
                    </a:p>
                  </a:txBody>
                  <a:tcPr marL="68584" marR="68584" marT="0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111537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CFC0B01-220A-0A44-7D3B-C6DCC844DE01}"/>
              </a:ext>
            </a:extLst>
          </p:cNvPr>
          <p:cNvSpPr/>
          <p:nvPr/>
        </p:nvSpPr>
        <p:spPr>
          <a:xfrm>
            <a:off x="1642278" y="556591"/>
            <a:ext cx="8853447" cy="72734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3C4D941B-BD6A-F9D3-3CEA-6ADC8CC338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2277" y="767318"/>
            <a:ext cx="8410575" cy="473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/>
          <a:lstStyle>
            <a:lvl1pPr>
              <a:lnSpc>
                <a:spcPct val="110000"/>
              </a:lnSpc>
              <a:spcBef>
                <a:spcPts val="675"/>
              </a:spcBef>
              <a:buClr>
                <a:schemeClr val="tx1"/>
              </a:buClr>
              <a:buFont typeface="Verdana" panose="020B0604030504040204" pitchFamily="34" charset="0"/>
              <a:buChar char="▪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1pPr>
            <a:lvl2pPr marL="23812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2pPr>
            <a:lvl3pPr marL="376238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3pPr>
            <a:lvl4pPr marL="514350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4pPr>
            <a:lvl5pPr marL="650875" indent="-136525">
              <a:lnSpc>
                <a:spcPct val="110000"/>
              </a:lnSpc>
              <a:spcBef>
                <a:spcPts val="225"/>
              </a:spcBef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5pPr>
            <a:lvl6pPr marL="11080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6pPr>
            <a:lvl7pPr marL="15652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7pPr>
            <a:lvl8pPr marL="20224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8pPr>
            <a:lvl9pPr marL="2479675" indent="-136525" eaLnBrk="0" fontAlgn="base" hangingPunct="0">
              <a:lnSpc>
                <a:spcPct val="110000"/>
              </a:lnSpc>
              <a:spcBef>
                <a:spcPts val="225"/>
              </a:spcBef>
              <a:spcAft>
                <a:spcPct val="0"/>
              </a:spcAft>
              <a:buFont typeface="Verdana" panose="020B0604030504040204" pitchFamily="34" charset="0"/>
              <a:buChar char="–"/>
              <a:defRPr sz="1100">
                <a:solidFill>
                  <a:schemeClr val="tx1"/>
                </a:solidFill>
                <a:latin typeface="Verdana" panose="020B0604030504040204" pitchFamily="34" charset="0"/>
              </a:defRPr>
            </a:lvl9pPr>
          </a:lstStyle>
          <a:p>
            <a:pPr algn="ctr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None/>
            </a:pPr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8. Turbo TSI: Kit Stability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79099235-4C42-266F-AF81-948F83E0252C}"/>
              </a:ext>
            </a:extLst>
          </p:cNvPr>
          <p:cNvGraphicFramePr>
            <a:graphicFrameLocks noGrp="1"/>
          </p:cNvGraphicFramePr>
          <p:nvPr/>
        </p:nvGraphicFramePr>
        <p:xfrm>
          <a:off x="1642280" y="1283932"/>
          <a:ext cx="8853446" cy="45702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612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0354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9895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69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0749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0749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1674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1674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81674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67527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8805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ime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SI positive serum 1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SI positive serum 2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SI positive serum 3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80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t 1</a:t>
                      </a:r>
                      <a:endParaRPr lang="en-US" sz="18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t 2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t 3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t 1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t 2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t 3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t 1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t 2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t 3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tx2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80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vg. IU/L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032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334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144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07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52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644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25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47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83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80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9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5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78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7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6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3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2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2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80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%CV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%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80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verall avg.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503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01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52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80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verall SD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1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0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3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80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verall %CV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8055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egression Statistics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8448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lope:</a:t>
                      </a:r>
                      <a:endParaRPr lang="en-US" sz="1800" b="1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35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266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0.0168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0.011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6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0.001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0.00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0.0003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0.001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5664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Y-int:</a:t>
                      </a:r>
                      <a:endParaRPr lang="en-US" sz="1800" b="1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612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121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278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99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4999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659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41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497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94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5664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 Value:</a:t>
                      </a:r>
                      <a:endParaRPr lang="en-US" sz="1800" b="1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566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54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27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97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707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19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257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71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39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6D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269190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B5076DF-60FB-9856-0657-C18C30969704}"/>
              </a:ext>
            </a:extLst>
          </p:cNvPr>
          <p:cNvSpPr/>
          <p:nvPr/>
        </p:nvSpPr>
        <p:spPr>
          <a:xfrm>
            <a:off x="1184743" y="1202635"/>
            <a:ext cx="9345435" cy="755374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D86A2356-98B7-080C-E27D-FCE28A13CC88}"/>
              </a:ext>
            </a:extLst>
          </p:cNvPr>
          <p:cNvSpPr txBox="1">
            <a:spLocks noChangeArrowheads="1"/>
          </p:cNvSpPr>
          <p:nvPr/>
        </p:nvSpPr>
        <p:spPr>
          <a:xfrm>
            <a:off x="1430890" y="1309343"/>
            <a:ext cx="8412162" cy="473075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9. Turbo TSI: Reproducibility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A259CC3-63A8-0095-45E2-FE1FC705DFB9}"/>
              </a:ext>
            </a:extLst>
          </p:cNvPr>
          <p:cNvGraphicFramePr>
            <a:graphicFrameLocks noGrp="1"/>
          </p:cNvGraphicFramePr>
          <p:nvPr/>
        </p:nvGraphicFramePr>
        <p:xfrm>
          <a:off x="1184743" y="1870006"/>
          <a:ext cx="9345435" cy="23472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697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2356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3517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24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6175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7711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7711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7711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7711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7711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77114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30294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ample Level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ean </a:t>
                      </a:r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oncentration (IU/L)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etween Site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etween Run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epeatability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otal</a:t>
                      </a:r>
                      <a:endParaRPr lang="en-US" sz="16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265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%CV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%CV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%CV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%CV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29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EVEL 1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2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7.1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.4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9.8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29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EVEL 2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4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.7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7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.5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029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EVEL 3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3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.4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3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.6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029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EVEL 4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2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.4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8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5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7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.3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0294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EVEL 5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1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.5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.0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1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83499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598</Words>
  <Application>Microsoft Office PowerPoint</Application>
  <PresentationFormat>Widescreen</PresentationFormat>
  <Paragraphs>780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Söhn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Olivo</dc:creator>
  <cp:lastModifiedBy>Paul Olivo</cp:lastModifiedBy>
  <cp:revision>5</cp:revision>
  <dcterms:created xsi:type="dcterms:W3CDTF">2023-08-27T21:25:22Z</dcterms:created>
  <dcterms:modified xsi:type="dcterms:W3CDTF">2024-07-16T19:38:36Z</dcterms:modified>
</cp:coreProperties>
</file>